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2" r:id="rId2"/>
    <p:sldId id="263" r:id="rId3"/>
    <p:sldId id="264" r:id="rId4"/>
    <p:sldId id="266" r:id="rId5"/>
  </p:sldIdLst>
  <p:sldSz cx="9601200" cy="12801600" type="A3"/>
  <p:notesSz cx="6797675" cy="9926638"/>
  <p:defaultTextStyle>
    <a:defPPr>
      <a:defRPr lang="en-US"/>
    </a:defPPr>
    <a:lvl1pPr marL="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MOU" lastIdx="2" clrIdx="0">
    <p:extLst>
      <p:ext uri="{19B8F6BF-5375-455C-9EA6-DF929625EA0E}">
        <p15:presenceInfo xmlns:p15="http://schemas.microsoft.com/office/powerpoint/2012/main" userId="Microsoft Office 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59" autoAdjust="0"/>
    <p:restoredTop sz="94671"/>
  </p:normalViewPr>
  <p:slideViewPr>
    <p:cSldViewPr snapToGrid="0" snapToObjects="1">
      <p:cViewPr>
        <p:scale>
          <a:sx n="70" d="100"/>
          <a:sy n="70" d="100"/>
        </p:scale>
        <p:origin x="1140" y="-26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9C778-3313-BB4D-AA46-1D59B3071783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0C335-48B5-B748-AF79-328603C8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0958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9C778-3313-BB4D-AA46-1D59B3071783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0C335-48B5-B748-AF79-328603C8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0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9C778-3313-BB4D-AA46-1D59B3071783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0C335-48B5-B748-AF79-328603C8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236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9C778-3313-BB4D-AA46-1D59B3071783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0C335-48B5-B748-AF79-328603C8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346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9C778-3313-BB4D-AA46-1D59B3071783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0C335-48B5-B748-AF79-328603C8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762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9C778-3313-BB4D-AA46-1D59B3071783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0C335-48B5-B748-AF79-328603C8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708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9C778-3313-BB4D-AA46-1D59B3071783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0C335-48B5-B748-AF79-328603C8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4366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9C778-3313-BB4D-AA46-1D59B3071783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0C335-48B5-B748-AF79-328603C8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414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9C778-3313-BB4D-AA46-1D59B3071783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0C335-48B5-B748-AF79-328603C8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969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9C778-3313-BB4D-AA46-1D59B3071783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0C335-48B5-B748-AF79-328603C8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432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B9C778-3313-BB4D-AA46-1D59B3071783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0C335-48B5-B748-AF79-328603C8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66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B9C778-3313-BB4D-AA46-1D59B3071783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0C335-48B5-B748-AF79-328603C878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641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F7DF3E30-C156-4981-AE19-8F529CEE3200}"/>
              </a:ext>
            </a:extLst>
          </p:cNvPr>
          <p:cNvSpPr txBox="1"/>
          <p:nvPr/>
        </p:nvSpPr>
        <p:spPr>
          <a:xfrm>
            <a:off x="4215238" y="591586"/>
            <a:ext cx="13161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F. </a:t>
            </a:r>
            <a:r>
              <a:rPr lang="en-US" sz="1600" b="1" i="1" dirty="0" err="1"/>
              <a:t>circinatum</a:t>
            </a:r>
            <a:r>
              <a:rPr lang="en-US" sz="1600" b="1" i="1" dirty="0"/>
              <a:t> </a:t>
            </a:r>
            <a:endParaRPr lang="en-US" sz="16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322D3F8-FB81-46D2-9ECF-F92B46170774}"/>
              </a:ext>
            </a:extLst>
          </p:cNvPr>
          <p:cNvSpPr txBox="1"/>
          <p:nvPr/>
        </p:nvSpPr>
        <p:spPr>
          <a:xfrm>
            <a:off x="4169571" y="6464756"/>
            <a:ext cx="14362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F. </a:t>
            </a:r>
            <a:r>
              <a:rPr lang="en-US" sz="1600" b="1" i="1" dirty="0" err="1"/>
              <a:t>temperatum</a:t>
            </a:r>
            <a:endParaRPr lang="en-US" sz="16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4D72927-E5F5-487C-A7A1-74C7DB37CF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019" y="1058045"/>
            <a:ext cx="9194463" cy="500599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184A0E3-DF3A-4691-BD1E-2F108ADF7E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9019" y="7204015"/>
            <a:ext cx="9194463" cy="500599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52074CD-E46E-4B05-9A7A-BA8F2C7001A7}"/>
              </a:ext>
            </a:extLst>
          </p:cNvPr>
          <p:cNvSpPr txBox="1"/>
          <p:nvPr/>
        </p:nvSpPr>
        <p:spPr>
          <a:xfrm>
            <a:off x="189019" y="211060"/>
            <a:ext cx="1741182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ZA" sz="2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3.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F046F9C-C140-47B1-8C25-B36E993A3C24}"/>
              </a:ext>
            </a:extLst>
          </p:cNvPr>
          <p:cNvSpPr txBox="1"/>
          <p:nvPr/>
        </p:nvSpPr>
        <p:spPr>
          <a:xfrm>
            <a:off x="189019" y="6218531"/>
            <a:ext cx="1741182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ZA" sz="2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3.2</a:t>
            </a:r>
          </a:p>
        </p:txBody>
      </p:sp>
    </p:spTree>
    <p:extLst>
      <p:ext uri="{BB962C8B-B14F-4D97-AF65-F5344CB8AC3E}">
        <p14:creationId xmlns:p14="http://schemas.microsoft.com/office/powerpoint/2010/main" val="28570702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25F0B0A7-07E9-4C49-8CB1-61ECF702BA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095" y="1089286"/>
            <a:ext cx="9185009" cy="4789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877C562-F091-4810-B9B3-C429B0A9EDED}"/>
              </a:ext>
            </a:extLst>
          </p:cNvPr>
          <p:cNvSpPr txBox="1"/>
          <p:nvPr/>
        </p:nvSpPr>
        <p:spPr>
          <a:xfrm>
            <a:off x="4420068" y="351882"/>
            <a:ext cx="1109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F. </a:t>
            </a:r>
            <a:r>
              <a:rPr lang="en-US" sz="1600" b="1" i="1" dirty="0" err="1"/>
              <a:t>nygamai</a:t>
            </a:r>
            <a:endParaRPr lang="en-US" sz="16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484EFAA-BA48-4C2A-BE3B-E5D1EBEC9680}"/>
              </a:ext>
            </a:extLst>
          </p:cNvPr>
          <p:cNvSpPr txBox="1"/>
          <p:nvPr/>
        </p:nvSpPr>
        <p:spPr>
          <a:xfrm>
            <a:off x="4230913" y="6400800"/>
            <a:ext cx="14877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F. verticillioides</a:t>
            </a:r>
            <a:endParaRPr lang="en-US" sz="16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AB60873-E8F7-4104-B04F-7DA6DD5D8A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8095" y="6940651"/>
            <a:ext cx="9185009" cy="499625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4B97794-2E30-4B52-87CE-C70771478B0E}"/>
              </a:ext>
            </a:extLst>
          </p:cNvPr>
          <p:cNvSpPr txBox="1"/>
          <p:nvPr/>
        </p:nvSpPr>
        <p:spPr>
          <a:xfrm>
            <a:off x="189019" y="211060"/>
            <a:ext cx="1741182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ZA" sz="2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3.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8BC32D2-D47A-4460-802B-34E6DE6609DB}"/>
              </a:ext>
            </a:extLst>
          </p:cNvPr>
          <p:cNvSpPr txBox="1"/>
          <p:nvPr/>
        </p:nvSpPr>
        <p:spPr>
          <a:xfrm>
            <a:off x="189019" y="6108412"/>
            <a:ext cx="1741182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ZA" sz="2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3.4</a:t>
            </a:r>
          </a:p>
        </p:txBody>
      </p:sp>
    </p:spTree>
    <p:extLst>
      <p:ext uri="{BB962C8B-B14F-4D97-AF65-F5344CB8AC3E}">
        <p14:creationId xmlns:p14="http://schemas.microsoft.com/office/powerpoint/2010/main" val="19545056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1037EDCA-226D-4879-903C-4C01C7868C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694" y="1158233"/>
            <a:ext cx="9071811" cy="472311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10F5B74-AC04-4BFF-9005-5CC899F76A58}"/>
              </a:ext>
            </a:extLst>
          </p:cNvPr>
          <p:cNvSpPr txBox="1"/>
          <p:nvPr/>
        </p:nvSpPr>
        <p:spPr>
          <a:xfrm>
            <a:off x="4245897" y="521159"/>
            <a:ext cx="10772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F. </a:t>
            </a:r>
            <a:r>
              <a:rPr lang="en-US" sz="1600" b="1" i="1" dirty="0" err="1"/>
              <a:t>fujikuroi</a:t>
            </a:r>
            <a:endParaRPr lang="en-US" sz="16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F0F2D5B-CDE7-4B0B-901B-DEAAE7D7F8C4}"/>
              </a:ext>
            </a:extLst>
          </p:cNvPr>
          <p:cNvSpPr txBox="1"/>
          <p:nvPr/>
        </p:nvSpPr>
        <p:spPr>
          <a:xfrm>
            <a:off x="4123684" y="6581698"/>
            <a:ext cx="13538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/>
              <a:t>F. </a:t>
            </a:r>
            <a:r>
              <a:rPr lang="en-US" sz="1600" b="1" i="1" dirty="0" err="1"/>
              <a:t>mangiferae</a:t>
            </a:r>
            <a:endParaRPr lang="en-US" sz="1600" b="1" dirty="0"/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C8DB0C46-1B57-4234-9664-B547622B94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4694" y="7158190"/>
            <a:ext cx="9071811" cy="472311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58175C6-1CBB-4D75-B689-6B3A62BD3C22}"/>
              </a:ext>
            </a:extLst>
          </p:cNvPr>
          <p:cNvSpPr txBox="1"/>
          <p:nvPr/>
        </p:nvSpPr>
        <p:spPr>
          <a:xfrm>
            <a:off x="189019" y="211060"/>
            <a:ext cx="1741182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ZA" sz="2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3.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96022C5-1AA5-4868-A2FC-F33E7795137C}"/>
              </a:ext>
            </a:extLst>
          </p:cNvPr>
          <p:cNvSpPr txBox="1"/>
          <p:nvPr/>
        </p:nvSpPr>
        <p:spPr>
          <a:xfrm>
            <a:off x="189019" y="6187601"/>
            <a:ext cx="1741182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ZA" sz="2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3.6</a:t>
            </a:r>
          </a:p>
        </p:txBody>
      </p:sp>
    </p:spTree>
    <p:extLst>
      <p:ext uri="{BB962C8B-B14F-4D97-AF65-F5344CB8AC3E}">
        <p14:creationId xmlns:p14="http://schemas.microsoft.com/office/powerpoint/2010/main" val="5178636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3C92960-9062-4646-845F-16ED5BEDC372}"/>
              </a:ext>
            </a:extLst>
          </p:cNvPr>
          <p:cNvSpPr txBox="1"/>
          <p:nvPr/>
        </p:nvSpPr>
        <p:spPr>
          <a:xfrm>
            <a:off x="613143" y="11188974"/>
            <a:ext cx="8294913" cy="15834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ZA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3.</a:t>
            </a:r>
            <a:r>
              <a:rPr lang="en-ZA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Changes in nucleotide frequencies per percentage GC content. These analyses were done using </a:t>
            </a:r>
            <a:r>
              <a:rPr lang="en-ZA" sz="10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OcculterCut</a:t>
            </a:r>
            <a:r>
              <a:rPr lang="en-ZA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v. 2.1 (Testa </a:t>
            </a:r>
            <a:r>
              <a:rPr lang="en-ZA" sz="1000" i="1" dirty="0">
                <a:latin typeface="Palatino Linotype" panose="02040502050505030304" pitchFamily="18" charset="0"/>
                <a:cs typeface="Arial" panose="020B0604020202020204" pitchFamily="34" charset="0"/>
              </a:rPr>
              <a:t>et al.</a:t>
            </a:r>
            <a:r>
              <a:rPr lang="en-ZA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2016) on the genome sequences investigated in this study (Figures S3.1-S3.8. A) Scatterplot illustrating changes in trinucleotide frequencies for the four different %GC content ranges. B) Scatterplot illustrating changes in dinucleotide frequencies for the four different %GC content ranges. C) Histogram showing changes in mononucleotide frequencies for the three different %GC content ranges. D) Pie chart showing the proportion of the genome characterized by each %GC content range.</a:t>
            </a:r>
            <a:r>
              <a:rPr lang="en-ZA" sz="1000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endParaRPr lang="en-ZA" sz="10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C7DCFBD-1E2D-4A5F-85F0-311D1C3D02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69" y="270092"/>
            <a:ext cx="9376461" cy="1091888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C201C17-2C04-42C1-AE9C-17C882948317}"/>
              </a:ext>
            </a:extLst>
          </p:cNvPr>
          <p:cNvSpPr txBox="1"/>
          <p:nvPr/>
        </p:nvSpPr>
        <p:spPr>
          <a:xfrm>
            <a:off x="189019" y="211060"/>
            <a:ext cx="1741182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ZA" sz="2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3.7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E24E46D-03D3-4A84-84A7-227E406473DF}"/>
              </a:ext>
            </a:extLst>
          </p:cNvPr>
          <p:cNvSpPr txBox="1"/>
          <p:nvPr/>
        </p:nvSpPr>
        <p:spPr>
          <a:xfrm>
            <a:off x="189019" y="5540055"/>
            <a:ext cx="1741182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ZA" sz="2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3.8</a:t>
            </a:r>
          </a:p>
        </p:txBody>
      </p:sp>
    </p:spTree>
    <p:extLst>
      <p:ext uri="{BB962C8B-B14F-4D97-AF65-F5344CB8AC3E}">
        <p14:creationId xmlns:p14="http://schemas.microsoft.com/office/powerpoint/2010/main" val="32000317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864</TotalTime>
  <Words>143</Words>
  <Application>Microsoft Office PowerPoint</Application>
  <PresentationFormat>A3 Paper (297x420 mm)</PresentationFormat>
  <Paragraphs>1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of. ET Steenkamp</dc:creator>
  <cp:lastModifiedBy>Ms. S van Wyk</cp:lastModifiedBy>
  <cp:revision>37</cp:revision>
  <cp:lastPrinted>2019-10-07T11:16:25Z</cp:lastPrinted>
  <dcterms:created xsi:type="dcterms:W3CDTF">2018-08-20T12:46:59Z</dcterms:created>
  <dcterms:modified xsi:type="dcterms:W3CDTF">2019-11-22T13:18:38Z</dcterms:modified>
</cp:coreProperties>
</file>